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436" userDrawn="1">
          <p15:clr>
            <a:srgbClr val="A4A3A4"/>
          </p15:clr>
        </p15:guide>
        <p15:guide id="4" orient="horz" pos="4407" userDrawn="1">
          <p15:clr>
            <a:srgbClr val="A4A3A4"/>
          </p15:clr>
        </p15:guide>
        <p15:guide id="5" orient="horz" pos="5677" userDrawn="1">
          <p15:clr>
            <a:srgbClr val="A4A3A4"/>
          </p15:clr>
        </p15:guide>
        <p15:guide id="6" pos="50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568552-42BF-41B2-A50E-B7B6266727A2}" name="Mireille Vankemmelbeke" initials="MV" userId="S::MireilleVankemmelbeke@scancell.co.uk::e2496c92-8ae2-4817-81db-1e2fdf7923b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58C44F0-9AB9-452C-A739-BC0554A02233}" v="1" dt="2024-06-21T15:33:30.91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070" y="36"/>
      </p:cViewPr>
      <p:guideLst>
        <p:guide orient="horz" pos="3840"/>
        <p:guide pos="2160"/>
        <p:guide orient="horz" pos="1436"/>
        <p:guide orient="horz" pos="4407"/>
        <p:guide orient="horz" pos="5677"/>
        <p:guide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eille Vankemmelbeke" userId="e2496c92-8ae2-4817-81db-1e2fdf7923b3" providerId="ADAL" clId="{958C44F0-9AB9-452C-A739-BC0554A02233}"/>
    <pc:docChg chg="custSel delSld modSld">
      <pc:chgData name="Mireille Vankemmelbeke" userId="e2496c92-8ae2-4817-81db-1e2fdf7923b3" providerId="ADAL" clId="{958C44F0-9AB9-452C-A739-BC0554A02233}" dt="2024-06-21T15:35:14.487" v="39" actId="20577"/>
      <pc:docMkLst>
        <pc:docMk/>
      </pc:docMkLst>
      <pc:sldChg chg="delSp modSp mod">
        <pc:chgData name="Mireille Vankemmelbeke" userId="e2496c92-8ae2-4817-81db-1e2fdf7923b3" providerId="ADAL" clId="{958C44F0-9AB9-452C-A739-BC0554A02233}" dt="2024-06-21T15:35:14.487" v="39" actId="20577"/>
        <pc:sldMkLst>
          <pc:docMk/>
          <pc:sldMk cId="3935331238" sldId="268"/>
        </pc:sldMkLst>
        <pc:spChg chg="mod">
          <ac:chgData name="Mireille Vankemmelbeke" userId="e2496c92-8ae2-4817-81db-1e2fdf7923b3" providerId="ADAL" clId="{958C44F0-9AB9-452C-A739-BC0554A02233}" dt="2024-06-21T15:35:14.487" v="39" actId="20577"/>
          <ac:spMkLst>
            <pc:docMk/>
            <pc:sldMk cId="3935331238" sldId="268"/>
            <ac:spMk id="7" creationId="{79992CF2-F656-6E86-8F97-EAE850C1D6A1}"/>
          </ac:spMkLst>
        </pc:spChg>
        <pc:spChg chg="del">
          <ac:chgData name="Mireille Vankemmelbeke" userId="e2496c92-8ae2-4817-81db-1e2fdf7923b3" providerId="ADAL" clId="{958C44F0-9AB9-452C-A739-BC0554A02233}" dt="2024-06-21T15:33:30.915" v="1" actId="478"/>
          <ac:spMkLst>
            <pc:docMk/>
            <pc:sldMk cId="3935331238" sldId="268"/>
            <ac:spMk id="8" creationId="{52FC7288-0277-B97D-DFD0-DDE8537FA61F}"/>
          </ac:spMkLst>
        </pc:spChg>
        <pc:spChg chg="del">
          <ac:chgData name="Mireille Vankemmelbeke" userId="e2496c92-8ae2-4817-81db-1e2fdf7923b3" providerId="ADAL" clId="{958C44F0-9AB9-452C-A739-BC0554A02233}" dt="2024-06-21T15:33:27.534" v="0" actId="478"/>
          <ac:spMkLst>
            <pc:docMk/>
            <pc:sldMk cId="3935331238" sldId="268"/>
            <ac:spMk id="9" creationId="{329F8FB0-E780-D480-8A95-4E9518BEA6E8}"/>
          </ac:spMkLst>
        </pc:spChg>
        <pc:spChg chg="del">
          <ac:chgData name="Mireille Vankemmelbeke" userId="e2496c92-8ae2-4817-81db-1e2fdf7923b3" providerId="ADAL" clId="{958C44F0-9AB9-452C-A739-BC0554A02233}" dt="2024-06-21T15:33:30.915" v="1" actId="478"/>
          <ac:spMkLst>
            <pc:docMk/>
            <pc:sldMk cId="3935331238" sldId="268"/>
            <ac:spMk id="11" creationId="{C837B6D7-0600-4F78-4369-7FBEBF40A86E}"/>
          </ac:spMkLst>
        </pc:spChg>
        <pc:spChg chg="del">
          <ac:chgData name="Mireille Vankemmelbeke" userId="e2496c92-8ae2-4817-81db-1e2fdf7923b3" providerId="ADAL" clId="{958C44F0-9AB9-452C-A739-BC0554A02233}" dt="2024-06-21T15:33:30.915" v="1" actId="478"/>
          <ac:spMkLst>
            <pc:docMk/>
            <pc:sldMk cId="3935331238" sldId="268"/>
            <ac:spMk id="12" creationId="{C8E8BB72-0835-9E31-583F-D761EAD1BFAD}"/>
          </ac:spMkLst>
        </pc:spChg>
        <pc:spChg chg="del">
          <ac:chgData name="Mireille Vankemmelbeke" userId="e2496c92-8ae2-4817-81db-1e2fdf7923b3" providerId="ADAL" clId="{958C44F0-9AB9-452C-A739-BC0554A02233}" dt="2024-06-21T15:33:30.915" v="1" actId="478"/>
          <ac:spMkLst>
            <pc:docMk/>
            <pc:sldMk cId="3935331238" sldId="268"/>
            <ac:spMk id="13" creationId="{F4565631-9F4F-C4D0-1CFB-0C52011139CC}"/>
          </ac:spMkLst>
        </pc:spChg>
        <pc:spChg chg="del">
          <ac:chgData name="Mireille Vankemmelbeke" userId="e2496c92-8ae2-4817-81db-1e2fdf7923b3" providerId="ADAL" clId="{958C44F0-9AB9-452C-A739-BC0554A02233}" dt="2024-06-21T15:33:27.534" v="0" actId="478"/>
          <ac:spMkLst>
            <pc:docMk/>
            <pc:sldMk cId="3935331238" sldId="268"/>
            <ac:spMk id="15" creationId="{6FC8C258-8525-A2DF-0C57-7C5EB072650E}"/>
          </ac:spMkLst>
        </pc:spChg>
        <pc:spChg chg="del">
          <ac:chgData name="Mireille Vankemmelbeke" userId="e2496c92-8ae2-4817-81db-1e2fdf7923b3" providerId="ADAL" clId="{958C44F0-9AB9-452C-A739-BC0554A02233}" dt="2024-06-21T15:33:30.915" v="1" actId="478"/>
          <ac:spMkLst>
            <pc:docMk/>
            <pc:sldMk cId="3935331238" sldId="268"/>
            <ac:spMk id="16" creationId="{3A6C0FD7-6959-1587-2E5D-AAEB3F8465DA}"/>
          </ac:spMkLst>
        </pc:spChg>
        <pc:spChg chg="del">
          <ac:chgData name="Mireille Vankemmelbeke" userId="e2496c92-8ae2-4817-81db-1e2fdf7923b3" providerId="ADAL" clId="{958C44F0-9AB9-452C-A739-BC0554A02233}" dt="2024-06-21T15:33:27.534" v="0" actId="478"/>
          <ac:spMkLst>
            <pc:docMk/>
            <pc:sldMk cId="3935331238" sldId="268"/>
            <ac:spMk id="18" creationId="{F4E7CC6C-854B-6244-16A0-7FDF0F15E499}"/>
          </ac:spMkLst>
        </pc:spChg>
        <pc:spChg chg="del">
          <ac:chgData name="Mireille Vankemmelbeke" userId="e2496c92-8ae2-4817-81db-1e2fdf7923b3" providerId="ADAL" clId="{958C44F0-9AB9-452C-A739-BC0554A02233}" dt="2024-06-21T15:33:27.534" v="0" actId="478"/>
          <ac:spMkLst>
            <pc:docMk/>
            <pc:sldMk cId="3935331238" sldId="268"/>
            <ac:spMk id="20" creationId="{647588B9-6635-78F5-91C7-12C820028590}"/>
          </ac:spMkLst>
        </pc:spChg>
        <pc:spChg chg="del">
          <ac:chgData name="Mireille Vankemmelbeke" userId="e2496c92-8ae2-4817-81db-1e2fdf7923b3" providerId="ADAL" clId="{958C44F0-9AB9-452C-A739-BC0554A02233}" dt="2024-06-21T15:33:27.534" v="0" actId="478"/>
          <ac:spMkLst>
            <pc:docMk/>
            <pc:sldMk cId="3935331238" sldId="268"/>
            <ac:spMk id="21" creationId="{8BA43F7C-912C-8ECD-6D13-02611A596775}"/>
          </ac:spMkLst>
        </pc:spChg>
        <pc:spChg chg="del mod">
          <ac:chgData name="Mireille Vankemmelbeke" userId="e2496c92-8ae2-4817-81db-1e2fdf7923b3" providerId="ADAL" clId="{958C44F0-9AB9-452C-A739-BC0554A02233}" dt="2024-06-21T15:34:33.963" v="13" actId="478"/>
          <ac:spMkLst>
            <pc:docMk/>
            <pc:sldMk cId="3935331238" sldId="268"/>
            <ac:spMk id="23" creationId="{1323D973-24A6-69E1-63BB-AAE450CCC9E6}"/>
          </ac:spMkLst>
        </pc:spChg>
        <pc:spChg chg="del">
          <ac:chgData name="Mireille Vankemmelbeke" userId="e2496c92-8ae2-4817-81db-1e2fdf7923b3" providerId="ADAL" clId="{958C44F0-9AB9-452C-A739-BC0554A02233}" dt="2024-06-21T15:33:30.915" v="1" actId="478"/>
          <ac:spMkLst>
            <pc:docMk/>
            <pc:sldMk cId="3935331238" sldId="268"/>
            <ac:spMk id="27" creationId="{0E1505E9-4973-7FF0-A4E6-FB325AF9754F}"/>
          </ac:spMkLst>
        </pc:spChg>
        <pc:spChg chg="del">
          <ac:chgData name="Mireille Vankemmelbeke" userId="e2496c92-8ae2-4817-81db-1e2fdf7923b3" providerId="ADAL" clId="{958C44F0-9AB9-452C-A739-BC0554A02233}" dt="2024-06-21T15:33:30.915" v="1" actId="478"/>
          <ac:spMkLst>
            <pc:docMk/>
            <pc:sldMk cId="3935331238" sldId="268"/>
            <ac:spMk id="28" creationId="{5A31E918-6C9F-EF42-0695-E0BDCB0A7C3D}"/>
          </ac:spMkLst>
        </pc:spChg>
        <pc:spChg chg="del">
          <ac:chgData name="Mireille Vankemmelbeke" userId="e2496c92-8ae2-4817-81db-1e2fdf7923b3" providerId="ADAL" clId="{958C44F0-9AB9-452C-A739-BC0554A02233}" dt="2024-06-21T15:33:30.915" v="1" actId="478"/>
          <ac:spMkLst>
            <pc:docMk/>
            <pc:sldMk cId="3935331238" sldId="268"/>
            <ac:spMk id="38" creationId="{C7DDF822-B914-4A88-9466-5C023EC4895A}"/>
          </ac:spMkLst>
        </pc:spChg>
        <pc:grpChg chg="del">
          <ac:chgData name="Mireille Vankemmelbeke" userId="e2496c92-8ae2-4817-81db-1e2fdf7923b3" providerId="ADAL" clId="{958C44F0-9AB9-452C-A739-BC0554A02233}" dt="2024-06-21T15:33:27.534" v="0" actId="478"/>
          <ac:grpSpMkLst>
            <pc:docMk/>
            <pc:sldMk cId="3935331238" sldId="268"/>
            <ac:grpSpMk id="4" creationId="{CA438E9F-47E1-3BF7-4DBF-311027FCC2F7}"/>
          </ac:grpSpMkLst>
        </pc:grpChg>
        <pc:grpChg chg="del">
          <ac:chgData name="Mireille Vankemmelbeke" userId="e2496c92-8ae2-4817-81db-1e2fdf7923b3" providerId="ADAL" clId="{958C44F0-9AB9-452C-A739-BC0554A02233}" dt="2024-06-21T15:33:30.915" v="1" actId="478"/>
          <ac:grpSpMkLst>
            <pc:docMk/>
            <pc:sldMk cId="3935331238" sldId="268"/>
            <ac:grpSpMk id="26" creationId="{FCF721D8-5A65-D3C4-1D36-67958D25B49C}"/>
          </ac:grpSpMkLst>
        </pc:grpChg>
        <pc:grpChg chg="del">
          <ac:chgData name="Mireille Vankemmelbeke" userId="e2496c92-8ae2-4817-81db-1e2fdf7923b3" providerId="ADAL" clId="{958C44F0-9AB9-452C-A739-BC0554A02233}" dt="2024-06-21T15:33:30.915" v="1" actId="478"/>
          <ac:grpSpMkLst>
            <pc:docMk/>
            <pc:sldMk cId="3935331238" sldId="268"/>
            <ac:grpSpMk id="35" creationId="{5D514B5C-2C50-A53F-809C-1892AF271196}"/>
          </ac:grpSpMkLst>
        </pc:grpChg>
        <pc:picChg chg="mod">
          <ac:chgData name="Mireille Vankemmelbeke" userId="e2496c92-8ae2-4817-81db-1e2fdf7923b3" providerId="ADAL" clId="{958C44F0-9AB9-452C-A739-BC0554A02233}" dt="2024-06-21T15:33:46.180" v="7" actId="1076"/>
          <ac:picMkLst>
            <pc:docMk/>
            <pc:sldMk cId="3935331238" sldId="268"/>
            <ac:picMk id="10" creationId="{86DA2D0F-ED30-6908-6CA2-9BFDE4C80CA0}"/>
          </ac:picMkLst>
        </pc:picChg>
        <pc:picChg chg="del">
          <ac:chgData name="Mireille Vankemmelbeke" userId="e2496c92-8ae2-4817-81db-1e2fdf7923b3" providerId="ADAL" clId="{958C44F0-9AB9-452C-A739-BC0554A02233}" dt="2024-06-21T15:33:27.534" v="0" actId="478"/>
          <ac:picMkLst>
            <pc:docMk/>
            <pc:sldMk cId="3935331238" sldId="268"/>
            <ac:picMk id="29" creationId="{9EF0A7CC-D44C-B781-66A4-D496E53F1767}"/>
          </ac:picMkLst>
        </pc:picChg>
        <pc:picChg chg="del">
          <ac:chgData name="Mireille Vankemmelbeke" userId="e2496c92-8ae2-4817-81db-1e2fdf7923b3" providerId="ADAL" clId="{958C44F0-9AB9-452C-A739-BC0554A02233}" dt="2024-06-21T15:33:30.915" v="1" actId="478"/>
          <ac:picMkLst>
            <pc:docMk/>
            <pc:sldMk cId="3935331238" sldId="268"/>
            <ac:picMk id="30" creationId="{42508664-B0C7-213A-5AAF-AFE57EC6C254}"/>
          </ac:picMkLst>
        </pc:picChg>
        <pc:picChg chg="del">
          <ac:chgData name="Mireille Vankemmelbeke" userId="e2496c92-8ae2-4817-81db-1e2fdf7923b3" providerId="ADAL" clId="{958C44F0-9AB9-452C-A739-BC0554A02233}" dt="2024-06-21T15:33:27.534" v="0" actId="478"/>
          <ac:picMkLst>
            <pc:docMk/>
            <pc:sldMk cId="3935331238" sldId="268"/>
            <ac:picMk id="32" creationId="{D71BB802-F8FA-B9F5-62FE-6DDA85DC0CC0}"/>
          </ac:picMkLst>
        </pc:picChg>
        <pc:picChg chg="del">
          <ac:chgData name="Mireille Vankemmelbeke" userId="e2496c92-8ae2-4817-81db-1e2fdf7923b3" providerId="ADAL" clId="{958C44F0-9AB9-452C-A739-BC0554A02233}" dt="2024-06-21T15:33:27.534" v="0" actId="478"/>
          <ac:picMkLst>
            <pc:docMk/>
            <pc:sldMk cId="3935331238" sldId="268"/>
            <ac:picMk id="34" creationId="{D395F453-6B32-21CF-E7D4-65CAAE1691F0}"/>
          </ac:picMkLst>
        </pc:picChg>
        <pc:picChg chg="del">
          <ac:chgData name="Mireille Vankemmelbeke" userId="e2496c92-8ae2-4817-81db-1e2fdf7923b3" providerId="ADAL" clId="{958C44F0-9AB9-452C-A739-BC0554A02233}" dt="2024-06-21T15:33:30.915" v="1" actId="478"/>
          <ac:picMkLst>
            <pc:docMk/>
            <pc:sldMk cId="3935331238" sldId="268"/>
            <ac:picMk id="37" creationId="{241969AE-1E1E-FCFD-3B20-ADCF726A6A95}"/>
          </ac:picMkLst>
        </pc:picChg>
        <pc:picChg chg="del">
          <ac:chgData name="Mireille Vankemmelbeke" userId="e2496c92-8ae2-4817-81db-1e2fdf7923b3" providerId="ADAL" clId="{958C44F0-9AB9-452C-A739-BC0554A02233}" dt="2024-06-21T15:33:30.915" v="1" actId="478"/>
          <ac:picMkLst>
            <pc:docMk/>
            <pc:sldMk cId="3935331238" sldId="268"/>
            <ac:picMk id="39" creationId="{8AA96BB3-6D0F-13D6-28DB-C113A52F9100}"/>
          </ac:picMkLst>
        </pc:picChg>
      </pc:sldChg>
      <pc:sldChg chg="del">
        <pc:chgData name="Mireille Vankemmelbeke" userId="e2496c92-8ae2-4817-81db-1e2fdf7923b3" providerId="ADAL" clId="{958C44F0-9AB9-452C-A739-BC0554A02233}" dt="2024-06-21T15:33:35.437" v="2" actId="47"/>
        <pc:sldMkLst>
          <pc:docMk/>
          <pc:sldMk cId="868960993" sldId="269"/>
        </pc:sldMkLst>
      </pc:sldChg>
      <pc:sldChg chg="del">
        <pc:chgData name="Mireille Vankemmelbeke" userId="e2496c92-8ae2-4817-81db-1e2fdf7923b3" providerId="ADAL" clId="{958C44F0-9AB9-452C-A739-BC0554A02233}" dt="2024-06-21T15:33:36.492" v="3" actId="47"/>
        <pc:sldMkLst>
          <pc:docMk/>
          <pc:sldMk cId="2268793920" sldId="27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ED1A2-C795-4A89-BC5A-004D576CF3D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34F97C-AF6A-4678-A188-E64139135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147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081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431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703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90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32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9854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74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59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1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68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485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3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1">
            <a:extLst>
              <a:ext uri="{FF2B5EF4-FFF2-40B4-BE49-F238E27FC236}">
                <a16:creationId xmlns:a16="http://schemas.microsoft.com/office/drawing/2014/main" id="{79992CF2-F656-6E86-8F97-EAE850C1D6A1}"/>
              </a:ext>
            </a:extLst>
          </p:cNvPr>
          <p:cNvSpPr txBox="1"/>
          <p:nvPr/>
        </p:nvSpPr>
        <p:spPr>
          <a:xfrm>
            <a:off x="-6918" y="937761"/>
            <a:ext cx="686491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9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 2</a:t>
            </a:r>
            <a:r>
              <a:rPr lang="en-GB" sz="9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 Target-dependent SCLC binding by SC134-TCB. SC134-TCB H740 cell binding (moderate-low expressor for FucGM1) and lack of binding to the FucGM1 negative cell line COLO205 . 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6DA2D0F-ED30-6908-6CA2-9BFDE4C80CA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1329" r="1421"/>
          <a:stretch/>
        </p:blipFill>
        <p:spPr>
          <a:xfrm>
            <a:off x="241935" y="1480588"/>
            <a:ext cx="1911246" cy="1260000"/>
          </a:xfrm>
          <a:prstGeom prst="rect">
            <a:avLst/>
          </a:prstGeom>
        </p:spPr>
      </p:pic>
      <p:sp>
        <p:nvSpPr>
          <p:cNvPr id="14" name="Title 1">
            <a:extLst>
              <a:ext uri="{FF2B5EF4-FFF2-40B4-BE49-F238E27FC236}">
                <a16:creationId xmlns:a16="http://schemas.microsoft.com/office/drawing/2014/main" id="{32A62937-3779-0616-05B7-500E83122552}"/>
              </a:ext>
            </a:extLst>
          </p:cNvPr>
          <p:cNvSpPr txBox="1">
            <a:spLocks/>
          </p:cNvSpPr>
          <p:nvPr/>
        </p:nvSpPr>
        <p:spPr>
          <a:xfrm>
            <a:off x="95251" y="359591"/>
            <a:ext cx="5604510" cy="4227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4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l Figures</a:t>
            </a:r>
            <a:endParaRPr lang="en-GB" sz="11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53312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4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eille Vankemmelbeke</dc:creator>
  <cp:lastModifiedBy>Mireille Vankemmelbeke</cp:lastModifiedBy>
  <cp:revision>3</cp:revision>
  <dcterms:created xsi:type="dcterms:W3CDTF">2024-03-08T14:10:38Z</dcterms:created>
  <dcterms:modified xsi:type="dcterms:W3CDTF">2024-06-21T15:35:19Z</dcterms:modified>
</cp:coreProperties>
</file>